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drawings/drawing3.xml" ContentType="application/vnd.openxmlformats-officedocument.drawingml.chartshapes+xml"/>
  <Override PartName="/ppt/charts/chart4.xml" ContentType="application/vnd.openxmlformats-officedocument.drawingml.chart+xml"/>
  <Override PartName="/ppt/drawings/drawing4.xml" ContentType="application/vnd.openxmlformats-officedocument.drawingml.chartshapes+xml"/>
  <Override PartName="/ppt/charts/chart5.xml" ContentType="application/vnd.openxmlformats-officedocument.drawingml.chart+xml"/>
  <Override PartName="/ppt/drawings/drawing5.xml" ContentType="application/vnd.openxmlformats-officedocument.drawingml.chartshapes+xml"/>
  <Override PartName="/ppt/charts/chart6.xml" ContentType="application/vnd.openxmlformats-officedocument.drawingml.chart+xml"/>
  <Override PartName="/ppt/drawings/drawing6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15620"/>
    <p:restoredTop sz="94675" autoAdjust="0"/>
  </p:normalViewPr>
  <p:slideViewPr>
    <p:cSldViewPr>
      <p:cViewPr varScale="1">
        <p:scale>
          <a:sx n="73" d="100"/>
          <a:sy n="73" d="100"/>
        </p:scale>
        <p:origin x="2442" y="84"/>
      </p:cViewPr>
      <p:guideLst>
        <p:guide orient="horz" pos="3120"/>
        <p:guide pos="2160"/>
      </p:guideLst>
    </p:cSldViewPr>
  </p:slideViewPr>
  <p:notesTextViewPr>
    <p:cViewPr>
      <p:scale>
        <a:sx n="200" d="100"/>
        <a:sy n="2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F:\My%20Documents%20HD\Papers%20in%20prog\2016\From%20A-K\AK260716\Data%20and%20charts%20-%20all%20screening%20mutants-test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F:\My%20Documents%20HD\Papers%20in%20prog\2016\From%20A-K\AK260716\Data%20and%20charts%20-%20all%20screening%20mutants-test.xlsx" TargetMode="Externa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.xml"/><Relationship Id="rId1" Type="http://schemas.openxmlformats.org/officeDocument/2006/relationships/oleObject" Target="file:///F:\My%20Documents%20HD\Papers%20in%20prog\2016\From%20A-K\AK260716\Data%20and%20charts%20-%20all%20screening%20mutants-test.xlsx" TargetMode="Externa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4.xml"/><Relationship Id="rId1" Type="http://schemas.openxmlformats.org/officeDocument/2006/relationships/oleObject" Target="file:///F:\My%20Documents%20HD\Papers%20in%20prog\2016\From%20A-K\AK260716\Data%20and%20charts%20-%20all%20screening%20mutants-test.xlsx" TargetMode="Externa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5.xml"/><Relationship Id="rId1" Type="http://schemas.openxmlformats.org/officeDocument/2006/relationships/oleObject" Target="file:///F:\My%20Documents%20HD\Papers%20in%20prog\2016\From%20A-K\AK260716\Data%20and%20charts%20-%20all%20screening%20mutants-test.xlsx" TargetMode="External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6.xml"/><Relationship Id="rId1" Type="http://schemas.openxmlformats.org/officeDocument/2006/relationships/oleObject" Target="file:///F:\My%20Documents%20HD\Papers%20in%20prog\2016\From%20A-K\AK260716\Data%20and%20charts%20-%20all%20screening%20mutants-test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888265914356328"/>
          <c:y val="5.4226693196471422E-2"/>
          <c:w val="0.76512404198460593"/>
          <c:h val="0.8338366289868751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4"/>
            <c:invertIfNegative val="0"/>
            <c:bubble3D val="0"/>
            <c:spPr>
              <a:solidFill>
                <a:schemeClr val="tx1">
                  <a:lumMod val="65000"/>
                  <a:lumOff val="3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9C8-4815-BE4A-07B625F69834}"/>
              </c:ext>
            </c:extLst>
          </c:dPt>
          <c:errBars>
            <c:errBarType val="plus"/>
            <c:errValType val="cust"/>
            <c:noEndCap val="0"/>
            <c:plus>
              <c:numRef>
                <c:f>'solvent charts all 24+120 h'!$L$19:$L$27</c:f>
                <c:numCache>
                  <c:formatCode>General</c:formatCode>
                  <c:ptCount val="9"/>
                  <c:pt idx="0">
                    <c:v>4.8562674281111553</c:v>
                  </c:pt>
                  <c:pt idx="1">
                    <c:v>7.8049129826453969</c:v>
                  </c:pt>
                  <c:pt idx="2">
                    <c:v>29.183328574147716</c:v>
                  </c:pt>
                  <c:pt idx="3">
                    <c:v>9.1833182093039412</c:v>
                  </c:pt>
                  <c:pt idx="4">
                    <c:v>7.1201424544336591</c:v>
                  </c:pt>
                  <c:pt idx="5">
                    <c:v>8.2613558209291522</c:v>
                  </c:pt>
                  <c:pt idx="6">
                    <c:v>5.7735026918962706</c:v>
                  </c:pt>
                  <c:pt idx="7">
                    <c:v>18.583146486355144</c:v>
                  </c:pt>
                  <c:pt idx="8">
                    <c:v>20.74447717666881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olvent charts all 24+120 h'!$A$4:$A$12</c:f>
              <c:strCache>
                <c:ptCount val="9"/>
                <c:pt idx="0">
                  <c:v>qsrA</c:v>
                </c:pt>
                <c:pt idx="1">
                  <c:v>qsrB</c:v>
                </c:pt>
                <c:pt idx="2">
                  <c:v>qsrC</c:v>
                </c:pt>
                <c:pt idx="3">
                  <c:v>qsrD</c:v>
                </c:pt>
                <c:pt idx="4">
                  <c:v>WT</c:v>
                </c:pt>
                <c:pt idx="5">
                  <c:v>qsrE</c:v>
                </c:pt>
                <c:pt idx="6">
                  <c:v>qsrF</c:v>
                </c:pt>
                <c:pt idx="7">
                  <c:v>qsrG</c:v>
                </c:pt>
                <c:pt idx="8">
                  <c:v>qsrH</c:v>
                </c:pt>
              </c:strCache>
            </c:strRef>
          </c:cat>
          <c:val>
            <c:numRef>
              <c:f>'solvent charts all 24+120 h'!$F$4:$F$12</c:f>
              <c:numCache>
                <c:formatCode>0</c:formatCode>
                <c:ptCount val="9"/>
                <c:pt idx="0">
                  <c:v>64.25</c:v>
                </c:pt>
                <c:pt idx="1">
                  <c:v>64.75</c:v>
                </c:pt>
                <c:pt idx="2">
                  <c:v>42.5</c:v>
                </c:pt>
                <c:pt idx="3">
                  <c:v>58.5</c:v>
                </c:pt>
                <c:pt idx="4">
                  <c:v>64.875</c:v>
                </c:pt>
                <c:pt idx="5">
                  <c:v>64.75</c:v>
                </c:pt>
                <c:pt idx="6">
                  <c:v>46.666666666666664</c:v>
                </c:pt>
                <c:pt idx="7">
                  <c:v>46.333333333333336</c:v>
                </c:pt>
                <c:pt idx="8">
                  <c:v>38.3333333333333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9C8-4815-BE4A-07B625F6983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20"/>
        <c:overlap val="-27"/>
        <c:axId val="106174720"/>
        <c:axId val="106188800"/>
      </c:barChart>
      <c:lineChart>
        <c:grouping val="standard"/>
        <c:varyColors val="0"/>
        <c:ser>
          <c:idx val="1"/>
          <c:order val="1"/>
          <c:tx>
            <c:strRef>
              <c:f>'solvent charts all 24+120 h'!$N$1</c:f>
              <c:strCache>
                <c:ptCount val="1"/>
                <c:pt idx="0">
                  <c:v>Reference lines</c:v>
                </c:pt>
              </c:strCache>
            </c:strRef>
          </c:tx>
          <c:spPr>
            <a:ln w="15875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none"/>
          </c:marker>
          <c:cat>
            <c:strRef>
              <c:f>'solvent charts all 24+120 h'!$A$4:$A$12</c:f>
              <c:strCache>
                <c:ptCount val="9"/>
                <c:pt idx="0">
                  <c:v>qsrA</c:v>
                </c:pt>
                <c:pt idx="1">
                  <c:v>qsrB</c:v>
                </c:pt>
                <c:pt idx="2">
                  <c:v>qsrC</c:v>
                </c:pt>
                <c:pt idx="3">
                  <c:v>qsrD</c:v>
                </c:pt>
                <c:pt idx="4">
                  <c:v>WT</c:v>
                </c:pt>
                <c:pt idx="5">
                  <c:v>qsrE</c:v>
                </c:pt>
                <c:pt idx="6">
                  <c:v>qsrF</c:v>
                </c:pt>
                <c:pt idx="7">
                  <c:v>qsrG</c:v>
                </c:pt>
                <c:pt idx="8">
                  <c:v>qsrH</c:v>
                </c:pt>
              </c:strCache>
            </c:strRef>
          </c:cat>
          <c:val>
            <c:numRef>
              <c:f>'solvent charts all 24+120 h'!$R$4:$R$12</c:f>
              <c:numCache>
                <c:formatCode>0</c:formatCode>
                <c:ptCount val="9"/>
                <c:pt idx="0">
                  <c:v>64.875</c:v>
                </c:pt>
                <c:pt idx="1">
                  <c:v>64.875</c:v>
                </c:pt>
                <c:pt idx="2">
                  <c:v>64.875</c:v>
                </c:pt>
                <c:pt idx="3">
                  <c:v>64.875</c:v>
                </c:pt>
                <c:pt idx="4">
                  <c:v>64.875</c:v>
                </c:pt>
                <c:pt idx="5">
                  <c:v>64.875</c:v>
                </c:pt>
                <c:pt idx="6">
                  <c:v>64.875</c:v>
                </c:pt>
                <c:pt idx="7">
                  <c:v>64.875</c:v>
                </c:pt>
                <c:pt idx="8">
                  <c:v>64.87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99C8-4815-BE4A-07B625F6983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06174720"/>
        <c:axId val="106188800"/>
      </c:lineChart>
      <c:catAx>
        <c:axId val="1061747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6188800"/>
        <c:crosses val="autoZero"/>
        <c:auto val="1"/>
        <c:lblAlgn val="ctr"/>
        <c:lblOffset val="100"/>
        <c:noMultiLvlLbl val="0"/>
      </c:catAx>
      <c:valAx>
        <c:axId val="106188800"/>
        <c:scaling>
          <c:orientation val="minMax"/>
          <c:max val="99.990000000000009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>
                    <a:solidFill>
                      <a:schemeClr val="tx1"/>
                    </a:solidFill>
                  </a:rPr>
                  <a:t>Acetone [mM]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0" sourceLinked="1"/>
        <c:majorTickMark val="out"/>
        <c:minorTickMark val="out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6174720"/>
        <c:crosses val="autoZero"/>
        <c:crossBetween val="between"/>
        <c:majorUnit val="20"/>
        <c:minorUnit val="10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11564189272579"/>
          <c:y val="5.4320987654320987E-2"/>
          <c:w val="0.7628665695784892"/>
          <c:h val="0.8320973822665254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4"/>
            <c:invertIfNegative val="0"/>
            <c:bubble3D val="0"/>
            <c:spPr>
              <a:solidFill>
                <a:schemeClr val="tx1">
                  <a:lumMod val="65000"/>
                  <a:lumOff val="3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CD3B-4D94-B4DD-F8BED16AB8A1}"/>
              </c:ext>
            </c:extLst>
          </c:dPt>
          <c:errBars>
            <c:errBarType val="plus"/>
            <c:errValType val="cust"/>
            <c:noEndCap val="0"/>
            <c:plus>
              <c:numRef>
                <c:f>'solvent charts all 24+120 h'!$K$19:$K$27</c:f>
                <c:numCache>
                  <c:formatCode>General</c:formatCode>
                  <c:ptCount val="9"/>
                  <c:pt idx="0">
                    <c:v>12.369316876852981</c:v>
                  </c:pt>
                  <c:pt idx="1">
                    <c:v>4.4347115652166904</c:v>
                  </c:pt>
                  <c:pt idx="2">
                    <c:v>49.080715832867256</c:v>
                  </c:pt>
                  <c:pt idx="3">
                    <c:v>9.0691785736085269</c:v>
                  </c:pt>
                  <c:pt idx="4">
                    <c:v>3.955105199973465</c:v>
                  </c:pt>
                  <c:pt idx="5">
                    <c:v>6.6833125519211407</c:v>
                  </c:pt>
                  <c:pt idx="6">
                    <c:v>17</c:v>
                  </c:pt>
                  <c:pt idx="7">
                    <c:v>24.684678108764835</c:v>
                  </c:pt>
                  <c:pt idx="8">
                    <c:v>30.23794525647093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olvent charts all 24+120 h'!$A$4:$A$12</c:f>
              <c:strCache>
                <c:ptCount val="9"/>
                <c:pt idx="0">
                  <c:v>qsrA</c:v>
                </c:pt>
                <c:pt idx="1">
                  <c:v>qsrB</c:v>
                </c:pt>
                <c:pt idx="2">
                  <c:v>qsrC</c:v>
                </c:pt>
                <c:pt idx="3">
                  <c:v>qsrD</c:v>
                </c:pt>
                <c:pt idx="4">
                  <c:v>WT</c:v>
                </c:pt>
                <c:pt idx="5">
                  <c:v>qsrE</c:v>
                </c:pt>
                <c:pt idx="6">
                  <c:v>qsrF</c:v>
                </c:pt>
                <c:pt idx="7">
                  <c:v>qsrG</c:v>
                </c:pt>
                <c:pt idx="8">
                  <c:v>qsrH</c:v>
                </c:pt>
              </c:strCache>
            </c:strRef>
          </c:cat>
          <c:val>
            <c:numRef>
              <c:f>'solvent charts all 24+120 h'!$E$4:$E$12</c:f>
              <c:numCache>
                <c:formatCode>0</c:formatCode>
                <c:ptCount val="9"/>
                <c:pt idx="0">
                  <c:v>111.5</c:v>
                </c:pt>
                <c:pt idx="1">
                  <c:v>119.5</c:v>
                </c:pt>
                <c:pt idx="2">
                  <c:v>81.25</c:v>
                </c:pt>
                <c:pt idx="3">
                  <c:v>114.25</c:v>
                </c:pt>
                <c:pt idx="4">
                  <c:v>110.75</c:v>
                </c:pt>
                <c:pt idx="5">
                  <c:v>118</c:v>
                </c:pt>
                <c:pt idx="6">
                  <c:v>99</c:v>
                </c:pt>
                <c:pt idx="7">
                  <c:v>81.666666666666671</c:v>
                </c:pt>
                <c:pt idx="8">
                  <c:v>71.3333333333333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D3B-4D94-B4DD-F8BED16AB8A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20"/>
        <c:overlap val="-27"/>
        <c:axId val="106233216"/>
        <c:axId val="107353216"/>
      </c:barChart>
      <c:lineChart>
        <c:grouping val="standard"/>
        <c:varyColors val="0"/>
        <c:ser>
          <c:idx val="1"/>
          <c:order val="1"/>
          <c:tx>
            <c:strRef>
              <c:f>'solvent charts all 24+120 h'!$N$1</c:f>
              <c:strCache>
                <c:ptCount val="1"/>
                <c:pt idx="0">
                  <c:v>Reference lines</c:v>
                </c:pt>
              </c:strCache>
            </c:strRef>
          </c:tx>
          <c:spPr>
            <a:ln w="15875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none"/>
          </c:marker>
          <c:cat>
            <c:strRef>
              <c:f>'solvent charts all 24+120 h'!$A$4:$A$12</c:f>
              <c:strCache>
                <c:ptCount val="9"/>
                <c:pt idx="0">
                  <c:v>qsrA</c:v>
                </c:pt>
                <c:pt idx="1">
                  <c:v>qsrB</c:v>
                </c:pt>
                <c:pt idx="2">
                  <c:v>qsrC</c:v>
                </c:pt>
                <c:pt idx="3">
                  <c:v>qsrD</c:v>
                </c:pt>
                <c:pt idx="4">
                  <c:v>WT</c:v>
                </c:pt>
                <c:pt idx="5">
                  <c:v>qsrE</c:v>
                </c:pt>
                <c:pt idx="6">
                  <c:v>qsrF</c:v>
                </c:pt>
                <c:pt idx="7">
                  <c:v>qsrG</c:v>
                </c:pt>
                <c:pt idx="8">
                  <c:v>qsrH</c:v>
                </c:pt>
              </c:strCache>
            </c:strRef>
          </c:cat>
          <c:val>
            <c:numRef>
              <c:f>'solvent charts all 24+120 h'!$Q$4:$Q$12</c:f>
              <c:numCache>
                <c:formatCode>0</c:formatCode>
                <c:ptCount val="9"/>
                <c:pt idx="0">
                  <c:v>110.75</c:v>
                </c:pt>
                <c:pt idx="1">
                  <c:v>110.75</c:v>
                </c:pt>
                <c:pt idx="2">
                  <c:v>110.75</c:v>
                </c:pt>
                <c:pt idx="3">
                  <c:v>110.75</c:v>
                </c:pt>
                <c:pt idx="4">
                  <c:v>110.75</c:v>
                </c:pt>
                <c:pt idx="5">
                  <c:v>110.75</c:v>
                </c:pt>
                <c:pt idx="6">
                  <c:v>110.75</c:v>
                </c:pt>
                <c:pt idx="7">
                  <c:v>110.75</c:v>
                </c:pt>
                <c:pt idx="8">
                  <c:v>110.7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CD3B-4D94-B4DD-F8BED16AB8A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06233216"/>
        <c:axId val="107353216"/>
      </c:lineChart>
      <c:catAx>
        <c:axId val="1062332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7353216"/>
        <c:crosses val="autoZero"/>
        <c:auto val="1"/>
        <c:lblAlgn val="ctr"/>
        <c:lblOffset val="100"/>
        <c:noMultiLvlLbl val="0"/>
      </c:catAx>
      <c:valAx>
        <c:axId val="107353216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>
                    <a:solidFill>
                      <a:schemeClr val="tx1"/>
                    </a:solidFill>
                  </a:rPr>
                  <a:t>Butanol [mM]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0" sourceLinked="1"/>
        <c:majorTickMark val="out"/>
        <c:minorTickMark val="out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6233216"/>
        <c:crosses val="autoZero"/>
        <c:crossBetween val="between"/>
        <c:majorUnit val="40"/>
        <c:minorUnit val="20"/>
      </c:valAx>
      <c:spPr>
        <a:solidFill>
          <a:schemeClr val="bg1"/>
        </a:solidFill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4"/>
            <c:invertIfNegative val="0"/>
            <c:bubble3D val="0"/>
            <c:spPr>
              <a:solidFill>
                <a:schemeClr val="tx1">
                  <a:lumMod val="65000"/>
                  <a:lumOff val="3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51C-4E07-9028-16C7FEE8A4DD}"/>
              </c:ext>
            </c:extLst>
          </c:dPt>
          <c:errBars>
            <c:errBarType val="plus"/>
            <c:errValType val="cust"/>
            <c:noEndCap val="0"/>
            <c:plus>
              <c:numRef>
                <c:f>'solvent charts all 24+120 h'!$M$19:$M$27</c:f>
                <c:numCache>
                  <c:formatCode>General</c:formatCode>
                  <c:ptCount val="9"/>
                  <c:pt idx="0">
                    <c:v>1.7320508075688772</c:v>
                  </c:pt>
                  <c:pt idx="1">
                    <c:v>4.1129875597510219</c:v>
                  </c:pt>
                  <c:pt idx="2">
                    <c:v>7.2571803523590805</c:v>
                  </c:pt>
                  <c:pt idx="3">
                    <c:v>1.707825127659933</c:v>
                  </c:pt>
                  <c:pt idx="4">
                    <c:v>1.6035674514745464</c:v>
                  </c:pt>
                  <c:pt idx="5">
                    <c:v>3.6968455021364721</c:v>
                  </c:pt>
                  <c:pt idx="6">
                    <c:v>1.5275252316519405</c:v>
                  </c:pt>
                  <c:pt idx="7">
                    <c:v>3.6055512754639891</c:v>
                  </c:pt>
                  <c:pt idx="8">
                    <c:v>4.582575694955839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olvent charts all 24+120 h'!$A$4:$A$12</c:f>
              <c:strCache>
                <c:ptCount val="9"/>
                <c:pt idx="0">
                  <c:v>qsrA</c:v>
                </c:pt>
                <c:pt idx="1">
                  <c:v>qsrB</c:v>
                </c:pt>
                <c:pt idx="2">
                  <c:v>qsrC</c:v>
                </c:pt>
                <c:pt idx="3">
                  <c:v>qsrD</c:v>
                </c:pt>
                <c:pt idx="4">
                  <c:v>WT</c:v>
                </c:pt>
                <c:pt idx="5">
                  <c:v>qsrE</c:v>
                </c:pt>
                <c:pt idx="6">
                  <c:v>qsrF</c:v>
                </c:pt>
                <c:pt idx="7">
                  <c:v>qsrG</c:v>
                </c:pt>
                <c:pt idx="8">
                  <c:v>qsrH</c:v>
                </c:pt>
              </c:strCache>
            </c:strRef>
          </c:cat>
          <c:val>
            <c:numRef>
              <c:f>'solvent charts all 24+120 h'!$G$4:$G$12</c:f>
              <c:numCache>
                <c:formatCode>0</c:formatCode>
                <c:ptCount val="9"/>
                <c:pt idx="0">
                  <c:v>15.5</c:v>
                </c:pt>
                <c:pt idx="1">
                  <c:v>20.25</c:v>
                </c:pt>
                <c:pt idx="2">
                  <c:v>12</c:v>
                </c:pt>
                <c:pt idx="3">
                  <c:v>16.25</c:v>
                </c:pt>
                <c:pt idx="4">
                  <c:v>14.5</c:v>
                </c:pt>
                <c:pt idx="5">
                  <c:v>19.5</c:v>
                </c:pt>
                <c:pt idx="6">
                  <c:v>13.666666666666666</c:v>
                </c:pt>
                <c:pt idx="7">
                  <c:v>12</c:v>
                </c:pt>
                <c:pt idx="8">
                  <c:v>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51C-4E07-9028-16C7FEE8A4D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20"/>
        <c:overlap val="-27"/>
        <c:axId val="107405312"/>
        <c:axId val="107406848"/>
      </c:barChart>
      <c:lineChart>
        <c:grouping val="standard"/>
        <c:varyColors val="0"/>
        <c:ser>
          <c:idx val="1"/>
          <c:order val="1"/>
          <c:tx>
            <c:strRef>
              <c:f>'solvent charts all 24+120 h'!$N$1</c:f>
              <c:strCache>
                <c:ptCount val="1"/>
                <c:pt idx="0">
                  <c:v>Reference lines</c:v>
                </c:pt>
              </c:strCache>
            </c:strRef>
          </c:tx>
          <c:spPr>
            <a:ln w="15875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none"/>
          </c:marker>
          <c:cat>
            <c:strRef>
              <c:f>'solvent charts all 24+120 h'!$A$4:$A$12</c:f>
              <c:strCache>
                <c:ptCount val="9"/>
                <c:pt idx="0">
                  <c:v>qsrA</c:v>
                </c:pt>
                <c:pt idx="1">
                  <c:v>qsrB</c:v>
                </c:pt>
                <c:pt idx="2">
                  <c:v>qsrC</c:v>
                </c:pt>
                <c:pt idx="3">
                  <c:v>qsrD</c:v>
                </c:pt>
                <c:pt idx="4">
                  <c:v>WT</c:v>
                </c:pt>
                <c:pt idx="5">
                  <c:v>qsrE</c:v>
                </c:pt>
                <c:pt idx="6">
                  <c:v>qsrF</c:v>
                </c:pt>
                <c:pt idx="7">
                  <c:v>qsrG</c:v>
                </c:pt>
                <c:pt idx="8">
                  <c:v>qsrH</c:v>
                </c:pt>
              </c:strCache>
            </c:strRef>
          </c:cat>
          <c:val>
            <c:numRef>
              <c:f>'solvent charts all 24+120 h'!$S$4:$S$12</c:f>
              <c:numCache>
                <c:formatCode>0</c:formatCode>
                <c:ptCount val="9"/>
                <c:pt idx="0">
                  <c:v>14.5</c:v>
                </c:pt>
                <c:pt idx="1">
                  <c:v>14.5</c:v>
                </c:pt>
                <c:pt idx="2">
                  <c:v>14.5</c:v>
                </c:pt>
                <c:pt idx="3">
                  <c:v>14.5</c:v>
                </c:pt>
                <c:pt idx="4">
                  <c:v>14.5</c:v>
                </c:pt>
                <c:pt idx="5">
                  <c:v>14.5</c:v>
                </c:pt>
                <c:pt idx="6">
                  <c:v>14.5</c:v>
                </c:pt>
                <c:pt idx="7">
                  <c:v>14.5</c:v>
                </c:pt>
                <c:pt idx="8">
                  <c:v>14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951C-4E07-9028-16C7FEE8A4D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07405312"/>
        <c:axId val="107406848"/>
      </c:lineChart>
      <c:catAx>
        <c:axId val="1074053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7406848"/>
        <c:crosses val="autoZero"/>
        <c:auto val="1"/>
        <c:lblAlgn val="ctr"/>
        <c:lblOffset val="100"/>
        <c:noMultiLvlLbl val="0"/>
      </c:catAx>
      <c:valAx>
        <c:axId val="107406848"/>
        <c:scaling>
          <c:orientation val="minMax"/>
          <c:max val="29.99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>
                    <a:solidFill>
                      <a:schemeClr val="tx1"/>
                    </a:solidFill>
                  </a:rPr>
                  <a:t>Ethanol [mM]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0" sourceLinked="1"/>
        <c:majorTickMark val="out"/>
        <c:minorTickMark val="out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7405312"/>
        <c:crosses val="autoZero"/>
        <c:crossBetween val="between"/>
        <c:majorUnit val="10"/>
        <c:minorUnit val="5"/>
      </c:valAx>
      <c:spPr>
        <a:solidFill>
          <a:schemeClr val="bg1"/>
        </a:solidFill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  <c:userShapes r:id="rId2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874421104957945"/>
          <c:y val="5.4307726158441719E-2"/>
          <c:w val="0.76529620246168362"/>
          <c:h val="0.8323429571303586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4"/>
            <c:invertIfNegative val="0"/>
            <c:bubble3D val="0"/>
            <c:spPr>
              <a:solidFill>
                <a:schemeClr val="tx1">
                  <a:lumMod val="65000"/>
                  <a:lumOff val="3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09A8-4032-B177-A884841F74A1}"/>
              </c:ext>
            </c:extLst>
          </c:dPt>
          <c:errBars>
            <c:errBarType val="plus"/>
            <c:errValType val="cust"/>
            <c:noEndCap val="0"/>
            <c:plus>
              <c:numRef>
                <c:f>'solvent charts all 24+120 h'!$H$19:$H$27</c:f>
                <c:numCache>
                  <c:formatCode>General</c:formatCode>
                  <c:ptCount val="9"/>
                  <c:pt idx="0">
                    <c:v>5.2519837521962431</c:v>
                  </c:pt>
                  <c:pt idx="1">
                    <c:v>4.6547466812563139</c:v>
                  </c:pt>
                  <c:pt idx="2">
                    <c:v>5.2519837521962431</c:v>
                  </c:pt>
                  <c:pt idx="3">
                    <c:v>3.7859388972001797</c:v>
                  </c:pt>
                  <c:pt idx="4">
                    <c:v>5.4231646006473273</c:v>
                  </c:pt>
                  <c:pt idx="5">
                    <c:v>1.4142135623730951</c:v>
                  </c:pt>
                  <c:pt idx="6">
                    <c:v>6.6583281184793917</c:v>
                  </c:pt>
                  <c:pt idx="7">
                    <c:v>15.307950004273378</c:v>
                  </c:pt>
                  <c:pt idx="8">
                    <c:v>2.645751311064590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olvent charts all 24+120 h'!$A$4:$A$12</c:f>
              <c:strCache>
                <c:ptCount val="9"/>
                <c:pt idx="0">
                  <c:v>qsrA</c:v>
                </c:pt>
                <c:pt idx="1">
                  <c:v>qsrB</c:v>
                </c:pt>
                <c:pt idx="2">
                  <c:v>qsrC</c:v>
                </c:pt>
                <c:pt idx="3">
                  <c:v>qsrD</c:v>
                </c:pt>
                <c:pt idx="4">
                  <c:v>WT</c:v>
                </c:pt>
                <c:pt idx="5">
                  <c:v>qsrE</c:v>
                </c:pt>
                <c:pt idx="6">
                  <c:v>qsrF</c:v>
                </c:pt>
                <c:pt idx="7">
                  <c:v>qsrG</c:v>
                </c:pt>
                <c:pt idx="8">
                  <c:v>qsrH</c:v>
                </c:pt>
              </c:strCache>
            </c:strRef>
          </c:cat>
          <c:val>
            <c:numRef>
              <c:f>'solvent charts all 24+120 h'!$B$4:$B$12</c:f>
              <c:numCache>
                <c:formatCode>0</c:formatCode>
                <c:ptCount val="9"/>
                <c:pt idx="0">
                  <c:v>7.25</c:v>
                </c:pt>
                <c:pt idx="1">
                  <c:v>20.5</c:v>
                </c:pt>
                <c:pt idx="2">
                  <c:v>10.75</c:v>
                </c:pt>
                <c:pt idx="3">
                  <c:v>13.666666666666666</c:v>
                </c:pt>
                <c:pt idx="4">
                  <c:v>14.375</c:v>
                </c:pt>
                <c:pt idx="5">
                  <c:v>4</c:v>
                </c:pt>
                <c:pt idx="6">
                  <c:v>14.333333333333334</c:v>
                </c:pt>
                <c:pt idx="7">
                  <c:v>17.333333333333332</c:v>
                </c:pt>
                <c:pt idx="8">
                  <c:v>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9A8-4032-B177-A884841F74A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20"/>
        <c:overlap val="-27"/>
        <c:axId val="107454848"/>
        <c:axId val="107456384"/>
      </c:barChart>
      <c:lineChart>
        <c:grouping val="standard"/>
        <c:varyColors val="0"/>
        <c:ser>
          <c:idx val="1"/>
          <c:order val="1"/>
          <c:tx>
            <c:strRef>
              <c:f>'solvent charts all 24+120 h'!$N$1</c:f>
              <c:strCache>
                <c:ptCount val="1"/>
                <c:pt idx="0">
                  <c:v>Reference lines</c:v>
                </c:pt>
              </c:strCache>
            </c:strRef>
          </c:tx>
          <c:spPr>
            <a:ln w="15875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none"/>
          </c:marker>
          <c:cat>
            <c:strRef>
              <c:f>'solvent charts all 24+120 h'!$A$4:$A$12</c:f>
              <c:strCache>
                <c:ptCount val="9"/>
                <c:pt idx="0">
                  <c:v>qsrA</c:v>
                </c:pt>
                <c:pt idx="1">
                  <c:v>qsrB</c:v>
                </c:pt>
                <c:pt idx="2">
                  <c:v>qsrC</c:v>
                </c:pt>
                <c:pt idx="3">
                  <c:v>qsrD</c:v>
                </c:pt>
                <c:pt idx="4">
                  <c:v>WT</c:v>
                </c:pt>
                <c:pt idx="5">
                  <c:v>qsrE</c:v>
                </c:pt>
                <c:pt idx="6">
                  <c:v>qsrF</c:v>
                </c:pt>
                <c:pt idx="7">
                  <c:v>qsrG</c:v>
                </c:pt>
                <c:pt idx="8">
                  <c:v>qsrH</c:v>
                </c:pt>
              </c:strCache>
            </c:strRef>
          </c:cat>
          <c:val>
            <c:numRef>
              <c:f>'solvent charts all 24+120 h'!$N$4:$N$12</c:f>
              <c:numCache>
                <c:formatCode>0</c:formatCode>
                <c:ptCount val="9"/>
                <c:pt idx="0">
                  <c:v>14.375</c:v>
                </c:pt>
                <c:pt idx="1">
                  <c:v>14.375</c:v>
                </c:pt>
                <c:pt idx="2">
                  <c:v>14.375</c:v>
                </c:pt>
                <c:pt idx="3">
                  <c:v>14.375</c:v>
                </c:pt>
                <c:pt idx="4">
                  <c:v>14.375</c:v>
                </c:pt>
                <c:pt idx="5">
                  <c:v>14.375</c:v>
                </c:pt>
                <c:pt idx="6">
                  <c:v>14.375</c:v>
                </c:pt>
                <c:pt idx="7">
                  <c:v>14.375</c:v>
                </c:pt>
                <c:pt idx="8">
                  <c:v>14.37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09A8-4032-B177-A884841F74A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07454848"/>
        <c:axId val="107456384"/>
      </c:lineChart>
      <c:catAx>
        <c:axId val="1074548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7456384"/>
        <c:crosses val="autoZero"/>
        <c:auto val="1"/>
        <c:lblAlgn val="ctr"/>
        <c:lblOffset val="100"/>
        <c:noMultiLvlLbl val="0"/>
      </c:catAx>
      <c:valAx>
        <c:axId val="107456384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>
                    <a:solidFill>
                      <a:schemeClr val="tx1"/>
                    </a:solidFill>
                  </a:rPr>
                  <a:t>Butanol [mM]</a:t>
                </a:r>
              </a:p>
            </c:rich>
          </c:tx>
          <c:layout>
            <c:manualLayout>
              <c:xMode val="edge"/>
              <c:yMode val="edge"/>
              <c:x val="4.5905594089140113E-2"/>
              <c:y val="0.3119852240692135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0" sourceLinked="1"/>
        <c:majorTickMark val="out"/>
        <c:minorTickMark val="out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7454848"/>
        <c:crosses val="autoZero"/>
        <c:crossBetween val="between"/>
        <c:majorUnit val="10"/>
        <c:minorUnit val="5"/>
      </c:valAx>
      <c:spPr>
        <a:solidFill>
          <a:schemeClr val="bg1"/>
        </a:solidFill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  <c:userShapes r:id="rId2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647512321147944"/>
          <c:y val="5.4320987654320987E-2"/>
          <c:w val="0.76754786529426766"/>
          <c:h val="0.8311196655973558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4"/>
            <c:invertIfNegative val="0"/>
            <c:bubble3D val="0"/>
            <c:spPr>
              <a:solidFill>
                <a:schemeClr val="tx1">
                  <a:lumMod val="65000"/>
                  <a:lumOff val="3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5F80-48C9-8A7D-EB255940705F}"/>
              </c:ext>
            </c:extLst>
          </c:dPt>
          <c:errBars>
            <c:errBarType val="plus"/>
            <c:errValType val="cust"/>
            <c:noEndCap val="0"/>
            <c:plus>
              <c:numRef>
                <c:f>'solvent charts all 24+120 h'!$J$19:$J$27</c:f>
                <c:numCache>
                  <c:formatCode>General</c:formatCode>
                  <c:ptCount val="9"/>
                  <c:pt idx="0">
                    <c:v>0.5</c:v>
                  </c:pt>
                  <c:pt idx="1">
                    <c:v>0.5</c:v>
                  </c:pt>
                  <c:pt idx="2">
                    <c:v>0.5</c:v>
                  </c:pt>
                  <c:pt idx="3">
                    <c:v>1</c:v>
                  </c:pt>
                  <c:pt idx="4">
                    <c:v>0.70710678118654757</c:v>
                  </c:pt>
                  <c:pt idx="5">
                    <c:v>0.5</c:v>
                  </c:pt>
                  <c:pt idx="6">
                    <c:v>0.57735026918962473</c:v>
                  </c:pt>
                  <c:pt idx="7">
                    <c:v>1.1547005383792526</c:v>
                  </c:pt>
                  <c:pt idx="8">
                    <c:v>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olvent charts all 24+120 h'!$A$4:$A$12</c:f>
              <c:strCache>
                <c:ptCount val="9"/>
                <c:pt idx="0">
                  <c:v>qsrA</c:v>
                </c:pt>
                <c:pt idx="1">
                  <c:v>qsrB</c:v>
                </c:pt>
                <c:pt idx="2">
                  <c:v>qsrC</c:v>
                </c:pt>
                <c:pt idx="3">
                  <c:v>qsrD</c:v>
                </c:pt>
                <c:pt idx="4">
                  <c:v>WT</c:v>
                </c:pt>
                <c:pt idx="5">
                  <c:v>qsrE</c:v>
                </c:pt>
                <c:pt idx="6">
                  <c:v>qsrF</c:v>
                </c:pt>
                <c:pt idx="7">
                  <c:v>qsrG</c:v>
                </c:pt>
                <c:pt idx="8">
                  <c:v>qsrH</c:v>
                </c:pt>
              </c:strCache>
            </c:strRef>
          </c:cat>
          <c:val>
            <c:numRef>
              <c:f>'solvent charts all 24+120 h'!$D$4:$D$12</c:f>
              <c:numCache>
                <c:formatCode>0</c:formatCode>
                <c:ptCount val="9"/>
                <c:pt idx="0">
                  <c:v>4.25</c:v>
                </c:pt>
                <c:pt idx="1">
                  <c:v>4.75</c:v>
                </c:pt>
                <c:pt idx="2">
                  <c:v>3.75</c:v>
                </c:pt>
                <c:pt idx="3">
                  <c:v>4</c:v>
                </c:pt>
                <c:pt idx="4">
                  <c:v>3.75</c:v>
                </c:pt>
                <c:pt idx="5">
                  <c:v>3.75</c:v>
                </c:pt>
                <c:pt idx="6">
                  <c:v>4.333333333333333</c:v>
                </c:pt>
                <c:pt idx="7">
                  <c:v>4.666666666666667</c:v>
                </c:pt>
                <c:pt idx="8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F80-48C9-8A7D-EB255940705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20"/>
        <c:overlap val="-27"/>
        <c:axId val="108090112"/>
        <c:axId val="108091648"/>
      </c:barChart>
      <c:lineChart>
        <c:grouping val="standard"/>
        <c:varyColors val="0"/>
        <c:ser>
          <c:idx val="1"/>
          <c:order val="1"/>
          <c:tx>
            <c:strRef>
              <c:f>'solvent charts all 24+120 h'!$N$1</c:f>
              <c:strCache>
                <c:ptCount val="1"/>
                <c:pt idx="0">
                  <c:v>Reference lines</c:v>
                </c:pt>
              </c:strCache>
            </c:strRef>
          </c:tx>
          <c:spPr>
            <a:ln w="15875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none"/>
          </c:marker>
          <c:cat>
            <c:strRef>
              <c:f>'solvent charts all 24+120 h'!$A$4:$A$12</c:f>
              <c:strCache>
                <c:ptCount val="9"/>
                <c:pt idx="0">
                  <c:v>qsrA</c:v>
                </c:pt>
                <c:pt idx="1">
                  <c:v>qsrB</c:v>
                </c:pt>
                <c:pt idx="2">
                  <c:v>qsrC</c:v>
                </c:pt>
                <c:pt idx="3">
                  <c:v>qsrD</c:v>
                </c:pt>
                <c:pt idx="4">
                  <c:v>WT</c:v>
                </c:pt>
                <c:pt idx="5">
                  <c:v>qsrE</c:v>
                </c:pt>
                <c:pt idx="6">
                  <c:v>qsrF</c:v>
                </c:pt>
                <c:pt idx="7">
                  <c:v>qsrG</c:v>
                </c:pt>
                <c:pt idx="8">
                  <c:v>qsrH</c:v>
                </c:pt>
              </c:strCache>
            </c:strRef>
          </c:cat>
          <c:val>
            <c:numRef>
              <c:f>'solvent charts all 24+120 h'!$P$4:$P$12</c:f>
              <c:numCache>
                <c:formatCode>0</c:formatCode>
                <c:ptCount val="9"/>
                <c:pt idx="0">
                  <c:v>3.75</c:v>
                </c:pt>
                <c:pt idx="1">
                  <c:v>3.75</c:v>
                </c:pt>
                <c:pt idx="2">
                  <c:v>3.75</c:v>
                </c:pt>
                <c:pt idx="3">
                  <c:v>3.75</c:v>
                </c:pt>
                <c:pt idx="4">
                  <c:v>3.75</c:v>
                </c:pt>
                <c:pt idx="5">
                  <c:v>3.75</c:v>
                </c:pt>
                <c:pt idx="6">
                  <c:v>3.75</c:v>
                </c:pt>
                <c:pt idx="7">
                  <c:v>3.75</c:v>
                </c:pt>
                <c:pt idx="8">
                  <c:v>3.7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5F80-48C9-8A7D-EB255940705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08090112"/>
        <c:axId val="108091648"/>
      </c:lineChart>
      <c:catAx>
        <c:axId val="1080901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8091648"/>
        <c:crosses val="autoZero"/>
        <c:auto val="1"/>
        <c:lblAlgn val="ctr"/>
        <c:lblOffset val="100"/>
        <c:noMultiLvlLbl val="0"/>
      </c:catAx>
      <c:valAx>
        <c:axId val="108091648"/>
        <c:scaling>
          <c:orientation val="minMax"/>
          <c:max val="7.99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>
                    <a:solidFill>
                      <a:schemeClr val="tx1"/>
                    </a:solidFill>
                  </a:rPr>
                  <a:t>Ethanol [mM]</a:t>
                </a:r>
              </a:p>
            </c:rich>
          </c:tx>
          <c:layout>
            <c:manualLayout>
              <c:xMode val="edge"/>
              <c:yMode val="edge"/>
              <c:x val="6.2695924764890276E-2"/>
              <c:y val="0.31811529114416254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0" sourceLinked="1"/>
        <c:majorTickMark val="out"/>
        <c:minorTickMark val="out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8090112"/>
        <c:crosses val="autoZero"/>
        <c:crossBetween val="between"/>
        <c:majorUnit val="2"/>
        <c:minorUnit val="1"/>
      </c:valAx>
      <c:spPr>
        <a:solidFill>
          <a:schemeClr val="bg1"/>
        </a:solidFill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0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  <c:userShapes r:id="rId2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874421104957945"/>
          <c:y val="5.9246038689608246E-2"/>
          <c:w val="0.76529620246168362"/>
          <c:h val="0.8274060033167753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4"/>
            <c:invertIfNegative val="0"/>
            <c:bubble3D val="0"/>
            <c:spPr>
              <a:solidFill>
                <a:schemeClr val="tx1">
                  <a:lumMod val="65000"/>
                  <a:lumOff val="3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B7AB-4208-A7BE-15C897329ED0}"/>
              </c:ext>
            </c:extLst>
          </c:dPt>
          <c:errBars>
            <c:errBarType val="plus"/>
            <c:errValType val="cust"/>
            <c:noEndCap val="0"/>
            <c:plus>
              <c:numRef>
                <c:f>'solvent charts all 24+120 h'!$I$19:$I$27</c:f>
                <c:numCache>
                  <c:formatCode>General</c:formatCode>
                  <c:ptCount val="9"/>
                  <c:pt idx="0">
                    <c:v>2.2173557826083452</c:v>
                  </c:pt>
                  <c:pt idx="1">
                    <c:v>1.5</c:v>
                  </c:pt>
                  <c:pt idx="2">
                    <c:v>2.6299556396765835</c:v>
                  </c:pt>
                  <c:pt idx="3">
                    <c:v>1.5275252316519452</c:v>
                  </c:pt>
                  <c:pt idx="4">
                    <c:v>2.9246489410818914</c:v>
                  </c:pt>
                  <c:pt idx="5">
                    <c:v>1.2583057392117916</c:v>
                  </c:pt>
                  <c:pt idx="6">
                    <c:v>2.6457513110645907</c:v>
                  </c:pt>
                  <c:pt idx="7">
                    <c:v>6.3508529610858826</c:v>
                  </c:pt>
                  <c:pt idx="8">
                    <c:v>2.081665999466133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olvent charts all 24+120 h'!$A$4:$A$12</c:f>
              <c:strCache>
                <c:ptCount val="9"/>
                <c:pt idx="0">
                  <c:v>qsrA</c:v>
                </c:pt>
                <c:pt idx="1">
                  <c:v>qsrB</c:v>
                </c:pt>
                <c:pt idx="2">
                  <c:v>qsrC</c:v>
                </c:pt>
                <c:pt idx="3">
                  <c:v>qsrD</c:v>
                </c:pt>
                <c:pt idx="4">
                  <c:v>WT</c:v>
                </c:pt>
                <c:pt idx="5">
                  <c:v>qsrE</c:v>
                </c:pt>
                <c:pt idx="6">
                  <c:v>qsrF</c:v>
                </c:pt>
                <c:pt idx="7">
                  <c:v>qsrG</c:v>
                </c:pt>
                <c:pt idx="8">
                  <c:v>qsrH</c:v>
                </c:pt>
              </c:strCache>
            </c:strRef>
          </c:cat>
          <c:val>
            <c:numRef>
              <c:f>'solvent charts all 24+120 h'!$C$4:$C$12</c:f>
              <c:numCache>
                <c:formatCode>0</c:formatCode>
                <c:ptCount val="9"/>
                <c:pt idx="0">
                  <c:v>4.75</c:v>
                </c:pt>
                <c:pt idx="1">
                  <c:v>12.25</c:v>
                </c:pt>
                <c:pt idx="2">
                  <c:v>6.25</c:v>
                </c:pt>
                <c:pt idx="3">
                  <c:v>7.333333333333333</c:v>
                </c:pt>
                <c:pt idx="4">
                  <c:v>8.625</c:v>
                </c:pt>
                <c:pt idx="5">
                  <c:v>3.75</c:v>
                </c:pt>
                <c:pt idx="6">
                  <c:v>8</c:v>
                </c:pt>
                <c:pt idx="7">
                  <c:v>8.6666666666666661</c:v>
                </c:pt>
                <c:pt idx="8">
                  <c:v>4.6666666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7AB-4208-A7BE-15C897329ED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20"/>
        <c:overlap val="-27"/>
        <c:axId val="107807104"/>
        <c:axId val="107808640"/>
      </c:barChart>
      <c:lineChart>
        <c:grouping val="standard"/>
        <c:varyColors val="0"/>
        <c:ser>
          <c:idx val="1"/>
          <c:order val="1"/>
          <c:tx>
            <c:strRef>
              <c:f>'solvent charts all 24+120 h'!$N$1</c:f>
              <c:strCache>
                <c:ptCount val="1"/>
                <c:pt idx="0">
                  <c:v>Reference lines</c:v>
                </c:pt>
              </c:strCache>
            </c:strRef>
          </c:tx>
          <c:spPr>
            <a:ln w="15875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none"/>
          </c:marker>
          <c:cat>
            <c:strRef>
              <c:f>'solvent charts all 24+120 h'!$A$4:$A$12</c:f>
              <c:strCache>
                <c:ptCount val="9"/>
                <c:pt idx="0">
                  <c:v>qsrA</c:v>
                </c:pt>
                <c:pt idx="1">
                  <c:v>qsrB</c:v>
                </c:pt>
                <c:pt idx="2">
                  <c:v>qsrC</c:v>
                </c:pt>
                <c:pt idx="3">
                  <c:v>qsrD</c:v>
                </c:pt>
                <c:pt idx="4">
                  <c:v>WT</c:v>
                </c:pt>
                <c:pt idx="5">
                  <c:v>qsrE</c:v>
                </c:pt>
                <c:pt idx="6">
                  <c:v>qsrF</c:v>
                </c:pt>
                <c:pt idx="7">
                  <c:v>qsrG</c:v>
                </c:pt>
                <c:pt idx="8">
                  <c:v>qsrH</c:v>
                </c:pt>
              </c:strCache>
            </c:strRef>
          </c:cat>
          <c:val>
            <c:numRef>
              <c:f>'solvent charts all 24+120 h'!$O$4:$O$12</c:f>
              <c:numCache>
                <c:formatCode>0</c:formatCode>
                <c:ptCount val="9"/>
                <c:pt idx="0">
                  <c:v>8.625</c:v>
                </c:pt>
                <c:pt idx="1">
                  <c:v>8.625</c:v>
                </c:pt>
                <c:pt idx="2">
                  <c:v>8.625</c:v>
                </c:pt>
                <c:pt idx="3">
                  <c:v>8.625</c:v>
                </c:pt>
                <c:pt idx="4">
                  <c:v>8.625</c:v>
                </c:pt>
                <c:pt idx="5">
                  <c:v>8.625</c:v>
                </c:pt>
                <c:pt idx="6">
                  <c:v>8.625</c:v>
                </c:pt>
                <c:pt idx="7">
                  <c:v>8.625</c:v>
                </c:pt>
                <c:pt idx="8">
                  <c:v>8.6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B7AB-4208-A7BE-15C897329ED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07807104"/>
        <c:axId val="107808640"/>
      </c:lineChart>
      <c:catAx>
        <c:axId val="1078071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7808640"/>
        <c:crosses val="autoZero"/>
        <c:auto val="1"/>
        <c:lblAlgn val="ctr"/>
        <c:lblOffset val="100"/>
        <c:noMultiLvlLbl val="0"/>
      </c:catAx>
      <c:valAx>
        <c:axId val="107808640"/>
        <c:scaling>
          <c:orientation val="minMax"/>
          <c:max val="18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>
                    <a:solidFill>
                      <a:schemeClr val="tx1"/>
                    </a:solidFill>
                  </a:rPr>
                  <a:t>Acetone [mM]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0" sourceLinked="1"/>
        <c:majorTickMark val="out"/>
        <c:minorTickMark val="out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7807104"/>
        <c:crosses val="autoZero"/>
        <c:crossBetween val="between"/>
        <c:majorUnit val="4"/>
        <c:minorUnit val="2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37252</cdr:x>
      <cdr:y>0.23457</cdr:y>
    </cdr:from>
    <cdr:to>
      <cdr:x>0.43176</cdr:x>
      <cdr:y>0.30154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131898" y="603252"/>
          <a:ext cx="179999" cy="17223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lIns="0" tIns="0" rIns="0" bIns="0" rtlCol="0" anchor="ctr" anchorCtr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GB" sz="1100" dirty="0"/>
            <a:t>*</a:t>
          </a:r>
        </a:p>
      </cdr:txBody>
    </cdr:sp>
  </cdr:relSizeAnchor>
  <cdr:relSizeAnchor xmlns:cdr="http://schemas.openxmlformats.org/drawingml/2006/chartDrawing">
    <cdr:from>
      <cdr:x>0.45716</cdr:x>
      <cdr:y>0.26975</cdr:y>
    </cdr:from>
    <cdr:to>
      <cdr:x>0.5164</cdr:x>
      <cdr:y>0.33672</cdr:y>
    </cdr:to>
    <cdr:sp macro="" textlink="">
      <cdr:nvSpPr>
        <cdr:cNvPr id="3" name="TextBox 1"/>
        <cdr:cNvSpPr txBox="1"/>
      </cdr:nvSpPr>
      <cdr:spPr>
        <a:xfrm xmlns:a="http://schemas.openxmlformats.org/drawingml/2006/main">
          <a:off x="1389060" y="693740"/>
          <a:ext cx="179999" cy="17223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lIns="0" tIns="0" rIns="0" bIns="0" rtlCol="0" anchor="ctr" anchorCtr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GB" sz="1100"/>
            <a:t>*</a:t>
          </a:r>
        </a:p>
      </cdr:txBody>
    </cdr:sp>
  </cdr:relSizeAnchor>
  <cdr:relSizeAnchor xmlns:cdr="http://schemas.openxmlformats.org/drawingml/2006/chartDrawing">
    <cdr:from>
      <cdr:x>0.71264</cdr:x>
      <cdr:y>0.39753</cdr:y>
    </cdr:from>
    <cdr:to>
      <cdr:x>0.77188</cdr:x>
      <cdr:y>0.4645</cdr:y>
    </cdr:to>
    <cdr:sp macro="" textlink="">
      <cdr:nvSpPr>
        <cdr:cNvPr id="4" name="TextBox 1"/>
        <cdr:cNvSpPr txBox="1"/>
      </cdr:nvSpPr>
      <cdr:spPr>
        <a:xfrm xmlns:a="http://schemas.openxmlformats.org/drawingml/2006/main">
          <a:off x="2165352" y="1022352"/>
          <a:ext cx="180000" cy="17223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lIns="0" tIns="0" rIns="0" bIns="0" rtlCol="0" anchor="ctr" anchorCtr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GB" sz="1100"/>
            <a:t>*</a:t>
          </a:r>
        </a:p>
      </cdr:txBody>
    </cdr:sp>
  </cdr:relSizeAnchor>
  <cdr:relSizeAnchor xmlns:cdr="http://schemas.openxmlformats.org/drawingml/2006/chartDrawing">
    <cdr:from>
      <cdr:x>0.79571</cdr:x>
      <cdr:y>0.29012</cdr:y>
    </cdr:from>
    <cdr:to>
      <cdr:x>0.85495</cdr:x>
      <cdr:y>0.35709</cdr:y>
    </cdr:to>
    <cdr:sp macro="" textlink="">
      <cdr:nvSpPr>
        <cdr:cNvPr id="5" name="TextBox 1"/>
        <cdr:cNvSpPr txBox="1"/>
      </cdr:nvSpPr>
      <cdr:spPr>
        <a:xfrm xmlns:a="http://schemas.openxmlformats.org/drawingml/2006/main">
          <a:off x="2417751" y="746128"/>
          <a:ext cx="179999" cy="17223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lIns="0" tIns="0" rIns="0" bIns="0" rtlCol="0" anchor="ctr" anchorCtr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GB" sz="1100"/>
            <a:t>*</a:t>
          </a:r>
        </a:p>
      </cdr:txBody>
    </cdr:sp>
  </cdr:relSizeAnchor>
  <cdr:relSizeAnchor xmlns:cdr="http://schemas.openxmlformats.org/drawingml/2006/chartDrawing">
    <cdr:from>
      <cdr:x>0.88192</cdr:x>
      <cdr:y>0.34383</cdr:y>
    </cdr:from>
    <cdr:to>
      <cdr:x>0.94116</cdr:x>
      <cdr:y>0.4108</cdr:y>
    </cdr:to>
    <cdr:sp macro="" textlink="">
      <cdr:nvSpPr>
        <cdr:cNvPr id="6" name="TextBox 1"/>
        <cdr:cNvSpPr txBox="1"/>
      </cdr:nvSpPr>
      <cdr:spPr>
        <a:xfrm xmlns:a="http://schemas.openxmlformats.org/drawingml/2006/main">
          <a:off x="2679690" y="884240"/>
          <a:ext cx="179999" cy="17223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lIns="0" tIns="0" rIns="0" bIns="0" rtlCol="0" anchor="ctr" anchorCtr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GB" sz="1100"/>
            <a:t>*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71139</cdr:x>
      <cdr:y>0.21753</cdr:y>
    </cdr:from>
    <cdr:to>
      <cdr:x>0.77063</cdr:x>
      <cdr:y>0.2845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2169172" y="559428"/>
          <a:ext cx="180634" cy="17223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lIns="0" tIns="0" rIns="0" bIns="0" rtlCol="0" anchor="ctr" anchorCtr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GB" sz="1100" dirty="0"/>
            <a:t>*</a:t>
          </a:r>
        </a:p>
      </cdr:txBody>
    </cdr:sp>
  </cdr:relSizeAnchor>
  <cdr:relSizeAnchor xmlns:cdr="http://schemas.openxmlformats.org/drawingml/2006/chartDrawing">
    <cdr:from>
      <cdr:x>0.79626</cdr:x>
      <cdr:y>0.26666</cdr:y>
    </cdr:from>
    <cdr:to>
      <cdr:x>0.85549</cdr:x>
      <cdr:y>0.33363</cdr:y>
    </cdr:to>
    <cdr:sp macro="" textlink="">
      <cdr:nvSpPr>
        <cdr:cNvPr id="3" name="TextBox 1"/>
        <cdr:cNvSpPr txBox="1"/>
      </cdr:nvSpPr>
      <cdr:spPr>
        <a:xfrm xmlns:a="http://schemas.openxmlformats.org/drawingml/2006/main">
          <a:off x="2427941" y="685793"/>
          <a:ext cx="180634" cy="17223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lIns="0" tIns="0" rIns="0" bIns="0" rtlCol="0" anchor="ctr" anchorCtr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GB" sz="1100" dirty="0"/>
            <a:t>*</a:t>
          </a:r>
        </a:p>
      </cdr:txBody>
    </cdr:sp>
  </cdr:relSizeAnchor>
  <cdr:relSizeAnchor xmlns:cdr="http://schemas.openxmlformats.org/drawingml/2006/chartDrawing">
    <cdr:from>
      <cdr:x>0.88191</cdr:x>
      <cdr:y>0.30617</cdr:y>
    </cdr:from>
    <cdr:to>
      <cdr:x>0.94115</cdr:x>
      <cdr:y>0.37314</cdr:y>
    </cdr:to>
    <cdr:sp macro="" textlink="">
      <cdr:nvSpPr>
        <cdr:cNvPr id="4" name="TextBox 1"/>
        <cdr:cNvSpPr txBox="1"/>
      </cdr:nvSpPr>
      <cdr:spPr>
        <a:xfrm xmlns:a="http://schemas.openxmlformats.org/drawingml/2006/main">
          <a:off x="2689131" y="787393"/>
          <a:ext cx="180635" cy="17223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lIns="0" tIns="0" rIns="0" bIns="0" rtlCol="0" anchor="ctr" anchorCtr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GB" sz="1100" dirty="0"/>
            <a:t>*</a:t>
          </a: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28526</cdr:x>
      <cdr:y>0.15309</cdr:y>
    </cdr:from>
    <cdr:to>
      <cdr:x>0.3445</cdr:x>
      <cdr:y>0.22006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866770" y="393703"/>
          <a:ext cx="179999" cy="17223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lIns="0" tIns="0" rIns="0" bIns="0" rtlCol="0" anchor="ctr" anchorCtr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GB" sz="1100" dirty="0"/>
            <a:t>*</a:t>
          </a:r>
        </a:p>
      </cdr:txBody>
    </cdr:sp>
  </cdr:relSizeAnchor>
  <cdr:relSizeAnchor xmlns:cdr="http://schemas.openxmlformats.org/drawingml/2006/chartDrawing">
    <cdr:from>
      <cdr:x>0.62695</cdr:x>
      <cdr:y>0.19012</cdr:y>
    </cdr:from>
    <cdr:to>
      <cdr:x>0.68619</cdr:x>
      <cdr:y>0.25709</cdr:y>
    </cdr:to>
    <cdr:sp macro="" textlink="">
      <cdr:nvSpPr>
        <cdr:cNvPr id="3" name="TextBox 1"/>
        <cdr:cNvSpPr txBox="1"/>
      </cdr:nvSpPr>
      <cdr:spPr>
        <a:xfrm xmlns:a="http://schemas.openxmlformats.org/drawingml/2006/main">
          <a:off x="1904986" y="488953"/>
          <a:ext cx="179999" cy="17223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lIns="0" tIns="0" rIns="0" bIns="0" rtlCol="0" anchor="ctr" anchorCtr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GB" sz="1100" dirty="0"/>
            <a:t>*</a:t>
          </a:r>
        </a:p>
      </cdr:txBody>
    </cdr:sp>
  </cdr:relSizeAnchor>
  <cdr:relSizeAnchor xmlns:cdr="http://schemas.openxmlformats.org/drawingml/2006/chartDrawing">
    <cdr:from>
      <cdr:x>0.79624</cdr:x>
      <cdr:y>0.39383</cdr:y>
    </cdr:from>
    <cdr:to>
      <cdr:x>0.85548</cdr:x>
      <cdr:y>0.4608</cdr:y>
    </cdr:to>
    <cdr:sp macro="" textlink="">
      <cdr:nvSpPr>
        <cdr:cNvPr id="4" name="TextBox 1"/>
        <cdr:cNvSpPr txBox="1"/>
      </cdr:nvSpPr>
      <cdr:spPr>
        <a:xfrm xmlns:a="http://schemas.openxmlformats.org/drawingml/2006/main">
          <a:off x="2419355" y="1012828"/>
          <a:ext cx="179999" cy="17223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lIns="0" tIns="0" rIns="0" bIns="0" rtlCol="0" anchor="ctr" anchorCtr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GB" sz="1100" dirty="0"/>
            <a:t>*</a:t>
          </a:r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20028</cdr:x>
      <cdr:y>0.58067</cdr:y>
    </cdr:from>
    <cdr:to>
      <cdr:x>0.25952</cdr:x>
      <cdr:y>0.64763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608543" y="1493342"/>
          <a:ext cx="179999" cy="17220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horzOverflow="clip" wrap="square" lIns="0" tIns="0" rIns="0" bIns="0" rtlCol="0" anchor="ctr" anchorCtr="0">
          <a:spAutoFit/>
        </a:bodyPr>
        <a:lstStyle xmlns:a="http://schemas.openxmlformats.org/drawingml/2006/main"/>
        <a:p xmlns:a="http://schemas.openxmlformats.org/drawingml/2006/main">
          <a:pPr algn="ctr"/>
          <a:r>
            <a:rPr lang="en-GB" sz="1100" dirty="0"/>
            <a:t>*</a:t>
          </a:r>
        </a:p>
      </cdr:txBody>
    </cdr:sp>
  </cdr:relSizeAnchor>
  <cdr:relSizeAnchor xmlns:cdr="http://schemas.openxmlformats.org/drawingml/2006/chartDrawing">
    <cdr:from>
      <cdr:x>0.28736</cdr:x>
      <cdr:y>0.30556</cdr:y>
    </cdr:from>
    <cdr:to>
      <cdr:x>0.3466</cdr:x>
      <cdr:y>0.37252</cdr:y>
    </cdr:to>
    <cdr:sp macro="" textlink="">
      <cdr:nvSpPr>
        <cdr:cNvPr id="3" name="TextBox 1"/>
        <cdr:cNvSpPr txBox="1"/>
      </cdr:nvSpPr>
      <cdr:spPr>
        <a:xfrm xmlns:a="http://schemas.openxmlformats.org/drawingml/2006/main">
          <a:off x="873135" y="785822"/>
          <a:ext cx="180000" cy="17220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lIns="0" tIns="0" rIns="0" bIns="0" rtlCol="0" anchor="ctr" anchorCtr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GB" sz="1100" dirty="0"/>
            <a:t>*</a:t>
          </a:r>
        </a:p>
      </cdr:txBody>
    </cdr:sp>
  </cdr:relSizeAnchor>
  <cdr:relSizeAnchor xmlns:cdr="http://schemas.openxmlformats.org/drawingml/2006/chartDrawing">
    <cdr:from>
      <cdr:x>0.62644</cdr:x>
      <cdr:y>0.71791</cdr:y>
    </cdr:from>
    <cdr:to>
      <cdr:x>0.68568</cdr:x>
      <cdr:y>0.78487</cdr:y>
    </cdr:to>
    <cdr:sp macro="" textlink="">
      <cdr:nvSpPr>
        <cdr:cNvPr id="5" name="TextBox 1"/>
        <cdr:cNvSpPr txBox="1"/>
      </cdr:nvSpPr>
      <cdr:spPr>
        <a:xfrm xmlns:a="http://schemas.openxmlformats.org/drawingml/2006/main">
          <a:off x="1903414" y="1846273"/>
          <a:ext cx="179999" cy="17220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lIns="0" tIns="0" rIns="0" bIns="0" rtlCol="0" anchor="ctr" anchorCtr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GB" sz="1100" dirty="0"/>
            <a:t>*</a:t>
          </a:r>
        </a:p>
      </cdr:txBody>
    </cdr:sp>
  </cdr:relSizeAnchor>
</c:userShapes>
</file>

<file path=ppt/drawings/drawing5.xml><?xml version="1.0" encoding="utf-8"?>
<c:userShapes xmlns:c="http://schemas.openxmlformats.org/drawingml/2006/chart">
  <cdr:relSizeAnchor xmlns:cdr="http://schemas.openxmlformats.org/drawingml/2006/chartDrawing">
    <cdr:from>
      <cdr:x>0.28505</cdr:x>
      <cdr:y>0.28124</cdr:y>
    </cdr:from>
    <cdr:to>
      <cdr:x>0.34429</cdr:x>
      <cdr:y>0.34821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866132" y="723268"/>
          <a:ext cx="179999" cy="17223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lIns="0" tIns="0" rIns="0" bIns="0" rtlCol="0" anchor="ctr" anchorCtr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GB" sz="1100" dirty="0" smtClean="0"/>
            <a:t>*                          </a:t>
          </a:r>
          <a:endParaRPr lang="en-GB" sz="1100" dirty="0"/>
        </a:p>
      </cdr:txBody>
    </cdr:sp>
  </cdr:relSizeAnchor>
</c:userShapes>
</file>

<file path=ppt/drawings/drawing6.xml><?xml version="1.0" encoding="utf-8"?>
<c:userShapes xmlns:c="http://schemas.openxmlformats.org/drawingml/2006/chart">
  <cdr:relSizeAnchor xmlns:cdr="http://schemas.openxmlformats.org/drawingml/2006/chartDrawing">
    <cdr:from>
      <cdr:x>0.28569</cdr:x>
      <cdr:y>0.20049</cdr:y>
    </cdr:from>
    <cdr:to>
      <cdr:x>0.34493</cdr:x>
      <cdr:y>0.26746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868055" y="515615"/>
          <a:ext cx="180000" cy="17223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lIns="0" tIns="0" rIns="0" bIns="0" rtlCol="0" anchor="ctr" anchorCtr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GB" sz="1100" dirty="0"/>
            <a:t>*</a:t>
          </a: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0D9F4B0-FFBD-40FA-8823-B5A1A3E5D941}" type="datetimeFigureOut">
              <a:rPr lang="en-GB" smtClean="0"/>
              <a:t>27/01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5A238ED-9173-4286-9C28-0753C17088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74808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A3957-464A-4D9D-AFD2-C9312CC3BCE8}" type="datetimeFigureOut">
              <a:rPr lang="en-GB" smtClean="0"/>
              <a:t>27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D1A38-D3BD-46A3-9E13-358D5B7CF4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587252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A3957-464A-4D9D-AFD2-C9312CC3BCE8}" type="datetimeFigureOut">
              <a:rPr lang="en-GB" smtClean="0"/>
              <a:t>27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D1A38-D3BD-46A3-9E13-358D5B7CF4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79785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A3957-464A-4D9D-AFD2-C9312CC3BCE8}" type="datetimeFigureOut">
              <a:rPr lang="en-GB" smtClean="0"/>
              <a:t>27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D1A38-D3BD-46A3-9E13-358D5B7CF4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1268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A3957-464A-4D9D-AFD2-C9312CC3BCE8}" type="datetimeFigureOut">
              <a:rPr lang="en-GB" smtClean="0"/>
              <a:t>27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D1A38-D3BD-46A3-9E13-358D5B7CF4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70244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A3957-464A-4D9D-AFD2-C9312CC3BCE8}" type="datetimeFigureOut">
              <a:rPr lang="en-GB" smtClean="0"/>
              <a:t>27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D1A38-D3BD-46A3-9E13-358D5B7CF4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92396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A3957-464A-4D9D-AFD2-C9312CC3BCE8}" type="datetimeFigureOut">
              <a:rPr lang="en-GB" smtClean="0"/>
              <a:t>27/01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D1A38-D3BD-46A3-9E13-358D5B7CF4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80429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A3957-464A-4D9D-AFD2-C9312CC3BCE8}" type="datetimeFigureOut">
              <a:rPr lang="en-GB" smtClean="0"/>
              <a:t>27/01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D1A38-D3BD-46A3-9E13-358D5B7CF4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098934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A3957-464A-4D9D-AFD2-C9312CC3BCE8}" type="datetimeFigureOut">
              <a:rPr lang="en-GB" smtClean="0"/>
              <a:t>27/01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D1A38-D3BD-46A3-9E13-358D5B7CF4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81652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A3957-464A-4D9D-AFD2-C9312CC3BCE8}" type="datetimeFigureOut">
              <a:rPr lang="en-GB" smtClean="0"/>
              <a:t>27/01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D1A38-D3BD-46A3-9E13-358D5B7CF4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086413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A3957-464A-4D9D-AFD2-C9312CC3BCE8}" type="datetimeFigureOut">
              <a:rPr lang="en-GB" smtClean="0"/>
              <a:t>27/01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D1A38-D3BD-46A3-9E13-358D5B7CF4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75661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A3957-464A-4D9D-AFD2-C9312CC3BCE8}" type="datetimeFigureOut">
              <a:rPr lang="en-GB" smtClean="0"/>
              <a:t>27/01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D1A38-D3BD-46A3-9E13-358D5B7CF4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9679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5A3957-464A-4D9D-AFD2-C9312CC3BCE8}" type="datetimeFigureOut">
              <a:rPr lang="en-GB" smtClean="0"/>
              <a:t>27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3D1A38-D3BD-46A3-9E13-358D5B7CF4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68113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" name="TextBox 613"/>
          <p:cNvSpPr txBox="1"/>
          <p:nvPr/>
        </p:nvSpPr>
        <p:spPr>
          <a:xfrm>
            <a:off x="277348" y="188640"/>
            <a:ext cx="960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angle 13"/>
          <p:cNvSpPr>
            <a:spLocks noChangeArrowheads="1"/>
          </p:cNvSpPr>
          <p:nvPr/>
        </p:nvSpPr>
        <p:spPr bwMode="auto">
          <a:xfrm>
            <a:off x="0" y="457200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5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/>
            </a:r>
            <a:br>
              <a:rPr kumimoji="0" lang="en-GB" altLang="en-US" sz="5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</a:br>
            <a:endParaRPr kumimoji="0" lang="en-GB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Rectangle 14"/>
          <p:cNvSpPr>
            <a:spLocks noChangeArrowheads="1"/>
          </p:cNvSpPr>
          <p:nvPr/>
        </p:nvSpPr>
        <p:spPr bwMode="auto">
          <a:xfrm>
            <a:off x="0" y="457200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Rectangle 15"/>
          <p:cNvSpPr>
            <a:spLocks noChangeArrowheads="1"/>
          </p:cNvSpPr>
          <p:nvPr/>
        </p:nvSpPr>
        <p:spPr bwMode="auto">
          <a:xfrm>
            <a:off x="0" y="457200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sp>
        <p:nvSpPr>
          <p:cNvPr id="17" name="Rectangle 16"/>
          <p:cNvSpPr>
            <a:spLocks noChangeArrowheads="1"/>
          </p:cNvSpPr>
          <p:nvPr/>
        </p:nvSpPr>
        <p:spPr bwMode="auto">
          <a:xfrm>
            <a:off x="0" y="10744200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Rectangle 30"/>
          <p:cNvSpPr>
            <a:spLocks noChangeArrowheads="1"/>
          </p:cNvSpPr>
          <p:nvPr/>
        </p:nvSpPr>
        <p:spPr bwMode="auto">
          <a:xfrm>
            <a:off x="152400" y="609600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Rectangle 31"/>
          <p:cNvSpPr>
            <a:spLocks noChangeArrowheads="1"/>
          </p:cNvSpPr>
          <p:nvPr/>
        </p:nvSpPr>
        <p:spPr bwMode="auto">
          <a:xfrm>
            <a:off x="152400" y="609600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sp>
        <p:nvSpPr>
          <p:cNvPr id="27" name="Rectangle 32"/>
          <p:cNvSpPr>
            <a:spLocks noChangeArrowheads="1"/>
          </p:cNvSpPr>
          <p:nvPr/>
        </p:nvSpPr>
        <p:spPr bwMode="auto">
          <a:xfrm>
            <a:off x="152400" y="10896600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331673" y="560512"/>
            <a:ext cx="6030638" cy="7063134"/>
            <a:chOff x="331673" y="1922314"/>
            <a:chExt cx="6030638" cy="7063134"/>
          </a:xfrm>
        </p:grpSpPr>
        <p:grpSp>
          <p:nvGrpSpPr>
            <p:cNvPr id="5" name="Group 4"/>
            <p:cNvGrpSpPr/>
            <p:nvPr/>
          </p:nvGrpSpPr>
          <p:grpSpPr>
            <a:xfrm>
              <a:off x="3313111" y="1928664"/>
              <a:ext cx="3049200" cy="7056784"/>
              <a:chOff x="3313111" y="1928664"/>
              <a:chExt cx="3049200" cy="7056784"/>
            </a:xfrm>
          </p:grpSpPr>
          <p:graphicFrame>
            <p:nvGraphicFramePr>
              <p:cNvPr id="94" name="Chart 93"/>
              <p:cNvGraphicFramePr/>
              <p:nvPr>
                <p:extLst>
                  <p:ext uri="{D42A27DB-BD31-4B8C-83A1-F6EECF244321}">
                    <p14:modId xmlns:p14="http://schemas.microsoft.com/office/powerpoint/2010/main" val="1239370282"/>
                  </p:ext>
                </p:extLst>
              </p:nvPr>
            </p:nvGraphicFramePr>
            <p:xfrm>
              <a:off x="3322637" y="4273178"/>
              <a:ext cx="3038475" cy="257175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graphicFrame>
            <p:nvGraphicFramePr>
              <p:cNvPr id="107" name="Chart 106"/>
              <p:cNvGraphicFramePr/>
              <p:nvPr>
                <p:extLst>
                  <p:ext uri="{D42A27DB-BD31-4B8C-83A1-F6EECF244321}">
                    <p14:modId xmlns:p14="http://schemas.microsoft.com/office/powerpoint/2010/main" val="1642961821"/>
                  </p:ext>
                </p:extLst>
              </p:nvPr>
            </p:nvGraphicFramePr>
            <p:xfrm>
              <a:off x="3313111" y="2144688"/>
              <a:ext cx="3049200" cy="257175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graphicFrame>
            <p:nvGraphicFramePr>
              <p:cNvPr id="95" name="Chart 94"/>
              <p:cNvGraphicFramePr/>
              <p:nvPr>
                <p:extLst>
                  <p:ext uri="{D42A27DB-BD31-4B8C-83A1-F6EECF244321}">
                    <p14:modId xmlns:p14="http://schemas.microsoft.com/office/powerpoint/2010/main" val="2688244052"/>
                  </p:ext>
                </p:extLst>
              </p:nvPr>
            </p:nvGraphicFramePr>
            <p:xfrm>
              <a:off x="3322637" y="6413698"/>
              <a:ext cx="3038475" cy="257175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19" name="Text Box 26"/>
              <p:cNvSpPr txBox="1">
                <a:spLocks noChangeArrowheads="1"/>
              </p:cNvSpPr>
              <p:nvPr/>
            </p:nvSpPr>
            <p:spPr bwMode="auto">
              <a:xfrm>
                <a:off x="4693976" y="1928664"/>
                <a:ext cx="731588" cy="3048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GB" altLang="en-US" sz="14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Calibri" pitchFamily="34" charset="0"/>
                    <a:cs typeface="Times New Roman" pitchFamily="18" charset="0"/>
                  </a:rPr>
                  <a:t>120 h</a:t>
                </a:r>
                <a:endParaRPr kumimoji="0" lang="en-GB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4" name="Group 3"/>
            <p:cNvGrpSpPr/>
            <p:nvPr/>
          </p:nvGrpSpPr>
          <p:grpSpPr>
            <a:xfrm>
              <a:off x="331673" y="1922314"/>
              <a:ext cx="3038475" cy="7056784"/>
              <a:chOff x="331673" y="1953433"/>
              <a:chExt cx="3038475" cy="7056784"/>
            </a:xfrm>
          </p:grpSpPr>
          <p:sp>
            <p:nvSpPr>
              <p:cNvPr id="2" name="Text Box 2"/>
              <p:cNvSpPr txBox="1">
                <a:spLocks noChangeArrowheads="1"/>
              </p:cNvSpPr>
              <p:nvPr/>
            </p:nvSpPr>
            <p:spPr bwMode="auto">
              <a:xfrm>
                <a:off x="1753959" y="1953433"/>
                <a:ext cx="619125" cy="3048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GB" altLang="en-US" sz="14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ea typeface="Calibri" pitchFamily="34" charset="0"/>
                    <a:cs typeface="Times New Roman" pitchFamily="18" charset="0"/>
                  </a:rPr>
                  <a:t>24 h</a:t>
                </a:r>
                <a:endParaRPr kumimoji="0" lang="en-GB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graphicFrame>
            <p:nvGraphicFramePr>
              <p:cNvPr id="106" name="Chart 105"/>
              <p:cNvGraphicFramePr/>
              <p:nvPr>
                <p:extLst>
                  <p:ext uri="{D42A27DB-BD31-4B8C-83A1-F6EECF244321}">
                    <p14:modId xmlns:p14="http://schemas.microsoft.com/office/powerpoint/2010/main" val="3700320696"/>
                  </p:ext>
                </p:extLst>
              </p:nvPr>
            </p:nvGraphicFramePr>
            <p:xfrm>
              <a:off x="331673" y="2169457"/>
              <a:ext cx="3038475" cy="257175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graphicFrame>
            <p:nvGraphicFramePr>
              <p:cNvPr id="109" name="Chart 108"/>
              <p:cNvGraphicFramePr/>
              <p:nvPr>
                <p:extLst>
                  <p:ext uri="{D42A27DB-BD31-4B8C-83A1-F6EECF244321}">
                    <p14:modId xmlns:p14="http://schemas.microsoft.com/office/powerpoint/2010/main" val="443706597"/>
                  </p:ext>
                </p:extLst>
              </p:nvPr>
            </p:nvGraphicFramePr>
            <p:xfrm>
              <a:off x="331673" y="6438467"/>
              <a:ext cx="3038475" cy="257175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graphicFrame>
            <p:nvGraphicFramePr>
              <p:cNvPr id="108" name="Chart 107"/>
              <p:cNvGraphicFramePr/>
              <p:nvPr>
                <p:extLst>
                  <p:ext uri="{D42A27DB-BD31-4B8C-83A1-F6EECF244321}">
                    <p14:modId xmlns:p14="http://schemas.microsoft.com/office/powerpoint/2010/main" val="3122593735"/>
                  </p:ext>
                </p:extLst>
              </p:nvPr>
            </p:nvGraphicFramePr>
            <p:xfrm>
              <a:off x="331673" y="4297947"/>
              <a:ext cx="3038475" cy="257175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"/>
              </a:graphicData>
            </a:graphic>
          </p:graphicFrame>
        </p:grpSp>
      </p:grpSp>
      <p:sp>
        <p:nvSpPr>
          <p:cNvPr id="8" name="Rectangle 7"/>
          <p:cNvSpPr/>
          <p:nvPr/>
        </p:nvSpPr>
        <p:spPr>
          <a:xfrm>
            <a:off x="658584" y="7857127"/>
            <a:ext cx="5794752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/>
              <a:t>Figure </a:t>
            </a:r>
            <a:r>
              <a:rPr lang="en-GB" sz="1200" b="1" smtClean="0"/>
              <a:t>S3. </a:t>
            </a:r>
            <a:r>
              <a:rPr lang="en-GB" sz="1200" dirty="0"/>
              <a:t>Solvent formation by </a:t>
            </a:r>
            <a:r>
              <a:rPr lang="en-GB" sz="1200" i="1" dirty="0"/>
              <a:t>C. acetobutylicum </a:t>
            </a:r>
            <a:r>
              <a:rPr lang="en-GB" sz="1200" i="1" dirty="0" err="1"/>
              <a:t>qsr</a:t>
            </a:r>
            <a:r>
              <a:rPr lang="en-GB" sz="1200" dirty="0"/>
              <a:t> mutants.</a:t>
            </a:r>
          </a:p>
          <a:p>
            <a:r>
              <a:rPr lang="en-GB" sz="1200" dirty="0"/>
              <a:t>Formation of butanol (A), acetone (B) and ethanol (C) was monitored in CBMS broth after 24 h (left hand panels) and 124 h (right hand panels) for all eight </a:t>
            </a:r>
            <a:r>
              <a:rPr lang="en-GB" sz="1200" i="1" dirty="0" err="1"/>
              <a:t>qsr</a:t>
            </a:r>
            <a:r>
              <a:rPr lang="en-GB" sz="1200" dirty="0"/>
              <a:t> mutants and compared to the ATCC 824 parent strain. (B) After 72 h, culture supernatant samples were taken and analysed for the produced acids (acetate, checks; butyrate, lines) and solvents (butanol, white; acetone, grey; ethanol, black). The data represent the mean of three independent CBMS cultures with error bars indicating the standard deviation. Significant differences (p≤0.05) compared to the </a:t>
            </a:r>
            <a:r>
              <a:rPr lang="en-GB" sz="1200" dirty="0" smtClean="0"/>
              <a:t>wild type </a:t>
            </a:r>
            <a:r>
              <a:rPr lang="en-GB" sz="1200" dirty="0"/>
              <a:t>are indicated by an asterisk.</a:t>
            </a:r>
          </a:p>
        </p:txBody>
      </p:sp>
    </p:spTree>
    <p:extLst>
      <p:ext uri="{BB962C8B-B14F-4D97-AF65-F5344CB8AC3E}">
        <p14:creationId xmlns:p14="http://schemas.microsoft.com/office/powerpoint/2010/main" val="10131774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05</TotalTime>
  <Words>186</Words>
  <Application>Microsoft Office PowerPoint</Application>
  <PresentationFormat>A4 Paper (210x297 mm)</PresentationFormat>
  <Paragraphs>2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>University of Nottingha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zer Klaus</dc:creator>
  <cp:lastModifiedBy>Klaus Winzer</cp:lastModifiedBy>
  <cp:revision>45</cp:revision>
  <cp:lastPrinted>2016-11-04T13:51:03Z</cp:lastPrinted>
  <dcterms:created xsi:type="dcterms:W3CDTF">2016-11-04T13:05:48Z</dcterms:created>
  <dcterms:modified xsi:type="dcterms:W3CDTF">2020-01-27T14:00:25Z</dcterms:modified>
</cp:coreProperties>
</file>